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40538" cy="93599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FEE49A7-284D-43A1-93C5-D77C3AF1DB8A}" v="3" dt="2021-08-17T09:28:12.52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>
        <p:scale>
          <a:sx n="120" d="100"/>
          <a:sy n="120" d="100"/>
        </p:scale>
        <p:origin x="1788" y="-2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manuela Camera" userId="5b6f701dccc636a3" providerId="LiveId" clId="{BFEE49A7-284D-43A1-93C5-D77C3AF1DB8A}"/>
    <pc:docChg chg="modSld">
      <pc:chgData name="Emanuela Camera" userId="5b6f701dccc636a3" providerId="LiveId" clId="{BFEE49A7-284D-43A1-93C5-D77C3AF1DB8A}" dt="2021-08-17T09:28:12.520" v="2" actId="1076"/>
      <pc:docMkLst>
        <pc:docMk/>
      </pc:docMkLst>
      <pc:sldChg chg="modSp">
        <pc:chgData name="Emanuela Camera" userId="5b6f701dccc636a3" providerId="LiveId" clId="{BFEE49A7-284D-43A1-93C5-D77C3AF1DB8A}" dt="2021-08-17T09:28:12.520" v="2" actId="1076"/>
        <pc:sldMkLst>
          <pc:docMk/>
          <pc:sldMk cId="291652791" sldId="256"/>
        </pc:sldMkLst>
        <pc:spChg chg="mod">
          <ac:chgData name="Emanuela Camera" userId="5b6f701dccc636a3" providerId="LiveId" clId="{BFEE49A7-284D-43A1-93C5-D77C3AF1DB8A}" dt="2021-08-17T09:28:03.384" v="1" actId="1076"/>
          <ac:spMkLst>
            <pc:docMk/>
            <pc:sldMk cId="291652791" sldId="256"/>
            <ac:spMk id="143" creationId="{B5D1CEB3-43A1-4151-AE9A-FB9ABD88323A}"/>
          </ac:spMkLst>
        </pc:spChg>
        <pc:spChg chg="mod">
          <ac:chgData name="Emanuela Camera" userId="5b6f701dccc636a3" providerId="LiveId" clId="{BFEE49A7-284D-43A1-93C5-D77C3AF1DB8A}" dt="2021-08-17T09:28:12.520" v="2" actId="1076"/>
          <ac:spMkLst>
            <pc:docMk/>
            <pc:sldMk cId="291652791" sldId="256"/>
            <ac:spMk id="144" creationId="{FDD74504-496A-41F6-B7C7-15F74AE2D163}"/>
          </ac:spMkLst>
        </pc:spChg>
      </pc:sldChg>
    </pc:docChg>
  </pc:docChgLst>
  <pc:docChgLst>
    <pc:chgData name="Emanuela Camera" userId="5b6f701dccc636a3" providerId="LiveId" clId="{0BECDC54-8DB6-42A1-A512-26B8407CA062}"/>
    <pc:docChg chg="modSld">
      <pc:chgData name="Emanuela Camera" userId="5b6f701dccc636a3" providerId="LiveId" clId="{0BECDC54-8DB6-42A1-A512-26B8407CA062}" dt="2021-08-17T09:29:53.584" v="3" actId="20577"/>
      <pc:docMkLst>
        <pc:docMk/>
      </pc:docMkLst>
      <pc:sldChg chg="modSp mod">
        <pc:chgData name="Emanuela Camera" userId="5b6f701dccc636a3" providerId="LiveId" clId="{0BECDC54-8DB6-42A1-A512-26B8407CA062}" dt="2021-08-17T09:29:53.584" v="3" actId="20577"/>
        <pc:sldMkLst>
          <pc:docMk/>
          <pc:sldMk cId="291652791" sldId="256"/>
        </pc:sldMkLst>
        <pc:spChg chg="mod">
          <ac:chgData name="Emanuela Camera" userId="5b6f701dccc636a3" providerId="LiveId" clId="{0BECDC54-8DB6-42A1-A512-26B8407CA062}" dt="2021-08-17T09:29:37.969" v="0" actId="20577"/>
          <ac:spMkLst>
            <pc:docMk/>
            <pc:sldMk cId="291652791" sldId="256"/>
            <ac:spMk id="141" creationId="{D362834F-5925-4449-9103-354388873329}"/>
          </ac:spMkLst>
        </pc:spChg>
        <pc:spChg chg="mod">
          <ac:chgData name="Emanuela Camera" userId="5b6f701dccc636a3" providerId="LiveId" clId="{0BECDC54-8DB6-42A1-A512-26B8407CA062}" dt="2021-08-17T09:29:40.338" v="1" actId="20577"/>
          <ac:spMkLst>
            <pc:docMk/>
            <pc:sldMk cId="291652791" sldId="256"/>
            <ac:spMk id="142" creationId="{C437BAAD-4230-4884-B0CD-2440D2C1456C}"/>
          </ac:spMkLst>
        </pc:spChg>
        <pc:spChg chg="mod">
          <ac:chgData name="Emanuela Camera" userId="5b6f701dccc636a3" providerId="LiveId" clId="{0BECDC54-8DB6-42A1-A512-26B8407CA062}" dt="2021-08-17T09:29:49.296" v="2" actId="20577"/>
          <ac:spMkLst>
            <pc:docMk/>
            <pc:sldMk cId="291652791" sldId="256"/>
            <ac:spMk id="143" creationId="{B5D1CEB3-43A1-4151-AE9A-FB9ABD88323A}"/>
          </ac:spMkLst>
        </pc:spChg>
        <pc:spChg chg="mod">
          <ac:chgData name="Emanuela Camera" userId="5b6f701dccc636a3" providerId="LiveId" clId="{0BECDC54-8DB6-42A1-A512-26B8407CA062}" dt="2021-08-17T09:29:53.584" v="3" actId="20577"/>
          <ac:spMkLst>
            <pc:docMk/>
            <pc:sldMk cId="291652791" sldId="256"/>
            <ac:spMk id="144" creationId="{FDD74504-496A-41F6-B7C7-15F74AE2D163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531818"/>
            <a:ext cx="5814457" cy="3258632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916115"/>
            <a:ext cx="5130404" cy="2259809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02F34-A5DE-4721-AA1F-FB971E37C487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CD472-DA1B-4AB7-8A71-6097D8A6C8C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367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02F34-A5DE-4721-AA1F-FB971E37C487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CD472-DA1B-4AB7-8A71-6097D8A6C8C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4157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98328"/>
            <a:ext cx="1474991" cy="7932083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98328"/>
            <a:ext cx="4339466" cy="7932083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02F34-A5DE-4721-AA1F-FB971E37C487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CD472-DA1B-4AB7-8A71-6097D8A6C8C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06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02F34-A5DE-4721-AA1F-FB971E37C487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CD472-DA1B-4AB7-8A71-6097D8A6C8C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429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333478"/>
            <a:ext cx="5899964" cy="3893458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6263769"/>
            <a:ext cx="5899964" cy="2047477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/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75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75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02F34-A5DE-4721-AA1F-FB971E37C487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CD472-DA1B-4AB7-8A71-6097D8A6C8C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549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491640"/>
            <a:ext cx="2907229" cy="5938771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491640"/>
            <a:ext cx="2907229" cy="5938771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02F34-A5DE-4721-AA1F-FB971E37C487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CD472-DA1B-4AB7-8A71-6097D8A6C8C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74451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98330"/>
            <a:ext cx="5899964" cy="1809148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294476"/>
            <a:ext cx="2893868" cy="1124487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418964"/>
            <a:ext cx="2893868" cy="5028780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294476"/>
            <a:ext cx="2908120" cy="1124487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418964"/>
            <a:ext cx="2908120" cy="5028780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02F34-A5DE-4721-AA1F-FB971E37C487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CD472-DA1B-4AB7-8A71-6097D8A6C8C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0343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02F34-A5DE-4721-AA1F-FB971E37C487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CD472-DA1B-4AB7-8A71-6097D8A6C8C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82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02F34-A5DE-4721-AA1F-FB971E37C487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CD472-DA1B-4AB7-8A71-6097D8A6C8C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270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23993"/>
            <a:ext cx="2206252" cy="2183977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347654"/>
            <a:ext cx="3463022" cy="6651596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807970"/>
            <a:ext cx="2206252" cy="5202112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02F34-A5DE-4721-AA1F-FB971E37C487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CD472-DA1B-4AB7-8A71-6097D8A6C8C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2740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623993"/>
            <a:ext cx="2206252" cy="2183977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347654"/>
            <a:ext cx="3463022" cy="6651596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807970"/>
            <a:ext cx="2206252" cy="5202112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B02F34-A5DE-4721-AA1F-FB971E37C487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CD472-DA1B-4AB7-8A71-6097D8A6C8C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965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98330"/>
            <a:ext cx="5899964" cy="1809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491640"/>
            <a:ext cx="5899964" cy="59387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8675243"/>
            <a:ext cx="1539121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B02F34-A5DE-4721-AA1F-FB971E37C487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8675243"/>
            <a:ext cx="2308682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8675243"/>
            <a:ext cx="1539121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5CD472-DA1B-4AB7-8A71-6097D8A6C8C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4745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132">
            <a:extLst>
              <a:ext uri="{FF2B5EF4-FFF2-40B4-BE49-F238E27FC236}">
                <a16:creationId xmlns:a16="http://schemas.microsoft.com/office/drawing/2014/main" id="{2A1EDD84-9394-4392-AB1E-D7C92E5A52E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4284" y="3189927"/>
            <a:ext cx="4257324" cy="24882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Parentesi graffa aperta 5">
            <a:extLst>
              <a:ext uri="{FF2B5EF4-FFF2-40B4-BE49-F238E27FC236}">
                <a16:creationId xmlns:a16="http://schemas.microsoft.com/office/drawing/2014/main" id="{2D853A30-0990-45B6-9CFB-EAEEAE921E1F}"/>
              </a:ext>
            </a:extLst>
          </p:cNvPr>
          <p:cNvSpPr/>
          <p:nvPr/>
        </p:nvSpPr>
        <p:spPr bwMode="auto">
          <a:xfrm rot="5400000" flipV="1">
            <a:off x="2470919" y="4153940"/>
            <a:ext cx="360000" cy="1207512"/>
          </a:xfrm>
          <a:prstGeom prst="leftBrac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GB" sz="728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86AD2E5E-898B-4EE1-A270-FDDDB6EF4D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55195" y="4212284"/>
            <a:ext cx="535724" cy="2994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 eaLnBrk="1" hangingPunct="1">
              <a:defRPr/>
            </a:pPr>
            <a:r>
              <a:rPr lang="it-IT" altLang="en-US" sz="673" dirty="0" err="1">
                <a:latin typeface="Arial" panose="020B0604020202020204" pitchFamily="34" charset="0"/>
                <a:cs typeface="Arial" panose="020B0604020202020204" pitchFamily="34" charset="0"/>
              </a:rPr>
              <a:t>FFAs</a:t>
            </a:r>
            <a:endParaRPr lang="it-IT" altLang="en-US" sz="67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eaLnBrk="1" hangingPunct="1">
              <a:defRPr/>
            </a:pPr>
            <a:r>
              <a:rPr lang="it-IT" altLang="en-US" sz="673" dirty="0">
                <a:latin typeface="Arial" panose="020B0604020202020204" pitchFamily="34" charset="0"/>
                <a:cs typeface="Arial" panose="020B0604020202020204" pitchFamily="34" charset="0"/>
              </a:rPr>
              <a:t>12≤C≤17</a:t>
            </a:r>
            <a:endParaRPr lang="en-GB" altLang="en-US" sz="67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Parentesi graffa aperta 7">
            <a:extLst>
              <a:ext uri="{FF2B5EF4-FFF2-40B4-BE49-F238E27FC236}">
                <a16:creationId xmlns:a16="http://schemas.microsoft.com/office/drawing/2014/main" id="{D81EA97C-59EF-4F76-BEAD-772252321A6F}"/>
              </a:ext>
            </a:extLst>
          </p:cNvPr>
          <p:cNvSpPr/>
          <p:nvPr/>
        </p:nvSpPr>
        <p:spPr bwMode="auto">
          <a:xfrm rot="5400000" flipV="1">
            <a:off x="3594434" y="3919512"/>
            <a:ext cx="402845" cy="697027"/>
          </a:xfrm>
          <a:prstGeom prst="leftBrac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GB" sz="728"/>
          </a:p>
        </p:txBody>
      </p:sp>
      <p:sp>
        <p:nvSpPr>
          <p:cNvPr id="9" name="CasellaDiTesto 134">
            <a:extLst>
              <a:ext uri="{FF2B5EF4-FFF2-40B4-BE49-F238E27FC236}">
                <a16:creationId xmlns:a16="http://schemas.microsoft.com/office/drawing/2014/main" id="{09BF022C-55DC-4779-9EBA-2851918B75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00279" y="3688217"/>
            <a:ext cx="535724" cy="2994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 eaLnBrk="1" hangingPunct="1">
              <a:defRPr/>
            </a:pPr>
            <a:r>
              <a:rPr lang="it-IT" altLang="en-US" sz="673" dirty="0" err="1">
                <a:latin typeface="Arial" panose="020B0604020202020204" pitchFamily="34" charset="0"/>
                <a:cs typeface="Arial" panose="020B0604020202020204" pitchFamily="34" charset="0"/>
              </a:rPr>
              <a:t>FFAs</a:t>
            </a:r>
            <a:endParaRPr lang="it-IT" altLang="en-US" sz="67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eaLnBrk="1" hangingPunct="1">
              <a:defRPr/>
            </a:pPr>
            <a:r>
              <a:rPr lang="it-IT" altLang="en-US" sz="673" dirty="0">
                <a:latin typeface="Arial" panose="020B0604020202020204" pitchFamily="34" charset="0"/>
                <a:cs typeface="Arial" panose="020B0604020202020204" pitchFamily="34" charset="0"/>
              </a:rPr>
              <a:t>18≤C≤21</a:t>
            </a:r>
            <a:endParaRPr lang="en-GB" altLang="en-US" sz="67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Parentesi graffa aperta 9">
            <a:extLst>
              <a:ext uri="{FF2B5EF4-FFF2-40B4-BE49-F238E27FC236}">
                <a16:creationId xmlns:a16="http://schemas.microsoft.com/office/drawing/2014/main" id="{D18CC094-EF92-4646-ADC6-71D0F3D9C2C8}"/>
              </a:ext>
            </a:extLst>
          </p:cNvPr>
          <p:cNvSpPr/>
          <p:nvPr/>
        </p:nvSpPr>
        <p:spPr bwMode="auto">
          <a:xfrm rot="5400000" flipV="1">
            <a:off x="4654904" y="3203818"/>
            <a:ext cx="360000" cy="1048238"/>
          </a:xfrm>
          <a:prstGeom prst="leftBrac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GB" sz="728"/>
          </a:p>
        </p:txBody>
      </p:sp>
      <p:sp>
        <p:nvSpPr>
          <p:cNvPr id="11" name="CasellaDiTesto 136">
            <a:extLst>
              <a:ext uri="{FF2B5EF4-FFF2-40B4-BE49-F238E27FC236}">
                <a16:creationId xmlns:a16="http://schemas.microsoft.com/office/drawing/2014/main" id="{FDA5777D-2CA6-4555-BA9D-78C4A0FC83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44897" y="3223979"/>
            <a:ext cx="405880" cy="2994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 eaLnBrk="1" hangingPunct="1">
              <a:defRPr/>
            </a:pPr>
            <a:r>
              <a:rPr lang="it-IT" altLang="en-US" sz="673" dirty="0" err="1">
                <a:latin typeface="Arial" panose="020B0604020202020204" pitchFamily="34" charset="0"/>
                <a:cs typeface="Arial" panose="020B0604020202020204" pitchFamily="34" charset="0"/>
              </a:rPr>
              <a:t>FFAs</a:t>
            </a:r>
            <a:endParaRPr lang="it-IT" altLang="en-US" sz="67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eaLnBrk="1" hangingPunct="1">
              <a:defRPr/>
            </a:pPr>
            <a:r>
              <a:rPr lang="it-IT" altLang="en-US" sz="673" dirty="0">
                <a:latin typeface="Arial" panose="020B0604020202020204" pitchFamily="34" charset="0"/>
                <a:cs typeface="Arial" panose="020B0604020202020204" pitchFamily="34" charset="0"/>
              </a:rPr>
              <a:t>C≥22</a:t>
            </a:r>
            <a:endParaRPr lang="en-GB" altLang="en-US" sz="67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Parentesi graffa aperta 12">
            <a:extLst>
              <a:ext uri="{FF2B5EF4-FFF2-40B4-BE49-F238E27FC236}">
                <a16:creationId xmlns:a16="http://schemas.microsoft.com/office/drawing/2014/main" id="{A473D47A-1FB9-4B96-AC55-AA5F14DF04E2}"/>
              </a:ext>
            </a:extLst>
          </p:cNvPr>
          <p:cNvSpPr/>
          <p:nvPr/>
        </p:nvSpPr>
        <p:spPr bwMode="auto">
          <a:xfrm rot="16200000">
            <a:off x="2745077" y="5320243"/>
            <a:ext cx="216000" cy="910645"/>
          </a:xfrm>
          <a:prstGeom prst="leftBrace">
            <a:avLst/>
          </a:prstGeom>
          <a:ln w="12700">
            <a:solidFill>
              <a:srgbClr val="00B0F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GB" sz="728"/>
          </a:p>
        </p:txBody>
      </p:sp>
      <p:sp>
        <p:nvSpPr>
          <p:cNvPr id="14" name="CasellaDiTesto 142">
            <a:extLst>
              <a:ext uri="{FF2B5EF4-FFF2-40B4-BE49-F238E27FC236}">
                <a16:creationId xmlns:a16="http://schemas.microsoft.com/office/drawing/2014/main" id="{B8DE7768-DC49-4266-8086-BAC7B51E65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85215" y="5928559"/>
            <a:ext cx="535724" cy="2994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 eaLnBrk="1" hangingPunct="1">
              <a:defRPr/>
            </a:pPr>
            <a:r>
              <a:rPr lang="it-IT" altLang="en-US" sz="673" dirty="0" err="1">
                <a:latin typeface="Arial" panose="020B0604020202020204" pitchFamily="34" charset="0"/>
                <a:cs typeface="Arial" panose="020B0604020202020204" pitchFamily="34" charset="0"/>
              </a:rPr>
              <a:t>FOHs</a:t>
            </a:r>
            <a:endParaRPr lang="it-IT" altLang="en-US" sz="67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eaLnBrk="1" hangingPunct="1">
              <a:defRPr/>
            </a:pPr>
            <a:r>
              <a:rPr lang="it-IT" altLang="en-US" sz="673" dirty="0">
                <a:latin typeface="Arial" panose="020B0604020202020204" pitchFamily="34" charset="0"/>
                <a:cs typeface="Arial" panose="020B0604020202020204" pitchFamily="34" charset="0"/>
              </a:rPr>
              <a:t>14≤C≤18</a:t>
            </a:r>
            <a:endParaRPr lang="en-GB" altLang="en-US" sz="67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9" name="Picture 1">
            <a:extLst>
              <a:ext uri="{FF2B5EF4-FFF2-40B4-BE49-F238E27FC236}">
                <a16:creationId xmlns:a16="http://schemas.microsoft.com/office/drawing/2014/main" id="{53756679-21A3-4FC8-B226-26048798720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0" t="7827" r="765"/>
          <a:stretch/>
        </p:blipFill>
        <p:spPr bwMode="auto">
          <a:xfrm>
            <a:off x="1514422" y="272543"/>
            <a:ext cx="3561736" cy="21362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0" name="Casella di testo 2">
            <a:extLst>
              <a:ext uri="{FF2B5EF4-FFF2-40B4-BE49-F238E27FC236}">
                <a16:creationId xmlns:a16="http://schemas.microsoft.com/office/drawing/2014/main" id="{EB508C2E-9FE3-48B0-B9CE-857F0608A6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82515" y="402845"/>
            <a:ext cx="518521" cy="2385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/>
          <a:p>
            <a:pPr>
              <a:lnSpc>
                <a:spcPct val="107000"/>
              </a:lnSpc>
              <a:spcAft>
                <a:spcPts val="416"/>
              </a:spcAft>
              <a:defRPr/>
            </a:pPr>
            <a:r>
              <a:rPr lang="en-GB" alt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qualene</a:t>
            </a:r>
            <a:endParaRPr lang="en-GB" alt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Casella di testo 3">
            <a:extLst>
              <a:ext uri="{FF2B5EF4-FFF2-40B4-BE49-F238E27FC236}">
                <a16:creationId xmlns:a16="http://schemas.microsoft.com/office/drawing/2014/main" id="{D362834F-5925-4449-9103-3543888733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65976" y="543349"/>
            <a:ext cx="277569" cy="2025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/>
          <a:p>
            <a:pPr>
              <a:lnSpc>
                <a:spcPct val="107000"/>
              </a:lnSpc>
              <a:spcAft>
                <a:spcPts val="416"/>
              </a:spcAft>
              <a:defRPr/>
            </a:pPr>
            <a:r>
              <a:rPr lang="en-GB" alt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s</a:t>
            </a:r>
            <a:endParaRPr lang="en-GB" alt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Casella di testo 4">
            <a:extLst>
              <a:ext uri="{FF2B5EF4-FFF2-40B4-BE49-F238E27FC236}">
                <a16:creationId xmlns:a16="http://schemas.microsoft.com/office/drawing/2014/main" id="{C437BAAD-4230-4884-B0CD-2440D2C145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7079" y="650540"/>
            <a:ext cx="296466" cy="2097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/>
          <a:p>
            <a:pPr>
              <a:lnSpc>
                <a:spcPct val="107000"/>
              </a:lnSpc>
              <a:spcAft>
                <a:spcPts val="416"/>
              </a:spcAft>
              <a:defRPr/>
            </a:pPr>
            <a:r>
              <a:rPr lang="en-GB" alt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s</a:t>
            </a:r>
            <a:endParaRPr lang="en-GB" alt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Casella di testo 5">
            <a:extLst>
              <a:ext uri="{FF2B5EF4-FFF2-40B4-BE49-F238E27FC236}">
                <a16:creationId xmlns:a16="http://schemas.microsoft.com/office/drawing/2014/main" id="{B5D1CEB3-43A1-4151-AE9A-FB9ABD8832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4284" y="1433729"/>
            <a:ext cx="209314" cy="176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/>
          <a:p>
            <a:pPr>
              <a:lnSpc>
                <a:spcPct val="107000"/>
              </a:lnSpc>
              <a:spcAft>
                <a:spcPts val="416"/>
              </a:spcAft>
              <a:defRPr/>
            </a:pPr>
            <a:r>
              <a:rPr lang="en-GB" alt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Gs</a:t>
            </a:r>
            <a:endParaRPr lang="en-GB" alt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Casella di testo 6">
            <a:extLst>
              <a:ext uri="{FF2B5EF4-FFF2-40B4-BE49-F238E27FC236}">
                <a16:creationId xmlns:a16="http://schemas.microsoft.com/office/drawing/2014/main" id="{FDD74504-496A-41F6-B7C7-15F74AE2D1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74622" y="1568771"/>
            <a:ext cx="241379" cy="176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/>
          <a:p>
            <a:pPr>
              <a:lnSpc>
                <a:spcPct val="107000"/>
              </a:lnSpc>
              <a:spcAft>
                <a:spcPts val="416"/>
              </a:spcAft>
              <a:defRPr/>
            </a:pPr>
            <a:r>
              <a:rPr lang="en-GB" alt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FAs</a:t>
            </a:r>
            <a:endParaRPr lang="en-GB" alt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Casella di testo 7">
            <a:extLst>
              <a:ext uri="{FF2B5EF4-FFF2-40B4-BE49-F238E27FC236}">
                <a16:creationId xmlns:a16="http://schemas.microsoft.com/office/drawing/2014/main" id="{856B07F7-26B2-48F0-B114-1483B771DC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30128" y="1624328"/>
            <a:ext cx="444457" cy="1763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/>
          <a:p>
            <a:pPr>
              <a:lnSpc>
                <a:spcPct val="107000"/>
              </a:lnSpc>
              <a:spcAft>
                <a:spcPts val="416"/>
              </a:spcAft>
              <a:defRPr/>
            </a:pPr>
            <a:r>
              <a:rPr lang="en-GB" alt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olesterol</a:t>
            </a:r>
            <a:endParaRPr lang="en-GB" alt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Casella di testo 9">
            <a:extLst>
              <a:ext uri="{FF2B5EF4-FFF2-40B4-BE49-F238E27FC236}">
                <a16:creationId xmlns:a16="http://schemas.microsoft.com/office/drawing/2014/main" id="{11E60D1D-4EE5-4545-888E-D170788E8F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41207" y="2672402"/>
            <a:ext cx="546916" cy="317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>
              <a:lnSpc>
                <a:spcPct val="107000"/>
              </a:lnSpc>
              <a:spcAft>
                <a:spcPts val="416"/>
              </a:spcAft>
              <a:defRPr/>
            </a:pPr>
            <a:r>
              <a:rPr lang="en-GB" altLang="en-US" sz="7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andard mixtures</a:t>
            </a:r>
            <a:endParaRPr lang="en-GB" alt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Casella di testo 10">
            <a:extLst>
              <a:ext uri="{FF2B5EF4-FFF2-40B4-BE49-F238E27FC236}">
                <a16:creationId xmlns:a16="http://schemas.microsoft.com/office/drawing/2014/main" id="{CA84914E-E01C-4D98-8A2A-8D4CDE9C817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61221" y="2393837"/>
            <a:ext cx="335239" cy="2038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>
              <a:lnSpc>
                <a:spcPct val="107000"/>
              </a:lnSpc>
              <a:spcAft>
                <a:spcPts val="416"/>
              </a:spcAft>
              <a:defRPr/>
            </a:pPr>
            <a:r>
              <a:rPr lang="en-GB" altLang="en-US" sz="7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QC</a:t>
            </a:r>
            <a:endParaRPr lang="en-GB" alt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Parentesi graffa aperta 147">
            <a:extLst>
              <a:ext uri="{FF2B5EF4-FFF2-40B4-BE49-F238E27FC236}">
                <a16:creationId xmlns:a16="http://schemas.microsoft.com/office/drawing/2014/main" id="{26405422-1EB4-4E7A-B48A-FD567DC37542}"/>
              </a:ext>
            </a:extLst>
          </p:cNvPr>
          <p:cNvSpPr/>
          <p:nvPr/>
        </p:nvSpPr>
        <p:spPr bwMode="auto">
          <a:xfrm rot="16200000">
            <a:off x="3639949" y="1424861"/>
            <a:ext cx="163086" cy="2196869"/>
          </a:xfrm>
          <a:prstGeom prst="leftBrace">
            <a:avLst>
              <a:gd name="adj1" fmla="val 8333"/>
              <a:gd name="adj2" fmla="val 49828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anchor="ctr"/>
          <a:lstStyle/>
          <a:p>
            <a:pPr eaLnBrk="1" hangingPunct="1">
              <a:defRPr/>
            </a:pPr>
            <a:endParaRPr lang="en-GB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Casella di testo 18">
            <a:extLst>
              <a:ext uri="{FF2B5EF4-FFF2-40B4-BE49-F238E27FC236}">
                <a16:creationId xmlns:a16="http://schemas.microsoft.com/office/drawing/2014/main" id="{DDDBE908-5386-488D-A773-F7284D4A2D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38760" y="2692322"/>
            <a:ext cx="1881166" cy="3377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>
              <a:lnSpc>
                <a:spcPct val="107000"/>
              </a:lnSpc>
              <a:spcAft>
                <a:spcPts val="416"/>
              </a:spcAft>
              <a:defRPr/>
            </a:pPr>
            <a:r>
              <a:rPr lang="en-GB" altLang="en-US" sz="7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ir-wise sebum extracts from foreheads and cheeks of six donors (NA, A)</a:t>
            </a:r>
            <a:endParaRPr lang="en-GB" alt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Casella di testo 19">
            <a:extLst>
              <a:ext uri="{FF2B5EF4-FFF2-40B4-BE49-F238E27FC236}">
                <a16:creationId xmlns:a16="http://schemas.microsoft.com/office/drawing/2014/main" id="{0E9F4447-3158-4FB6-87E5-E6F8BB08E6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38256" y="2408796"/>
            <a:ext cx="488518" cy="2329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>
              <a:lnSpc>
                <a:spcPct val="107000"/>
              </a:lnSpc>
              <a:spcAft>
                <a:spcPts val="416"/>
              </a:spcAft>
              <a:defRPr/>
            </a:pPr>
            <a:r>
              <a:rPr lang="en-GB" altLang="en-US" sz="7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lank tape</a:t>
            </a:r>
            <a:endParaRPr lang="en-GB" alt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Casella di testo 11">
            <a:extLst>
              <a:ext uri="{FF2B5EF4-FFF2-40B4-BE49-F238E27FC236}">
                <a16:creationId xmlns:a16="http://schemas.microsoft.com/office/drawing/2014/main" id="{E4A6D96F-5693-4D69-A081-FC546839DC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2013" y="2423333"/>
            <a:ext cx="461905" cy="337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>
              <a:lnSpc>
                <a:spcPct val="107000"/>
              </a:lnSpc>
              <a:spcAft>
                <a:spcPts val="416"/>
              </a:spcAft>
              <a:defRPr/>
            </a:pPr>
            <a:r>
              <a:rPr lang="en-GB" altLang="en-US" sz="7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lank extract</a:t>
            </a:r>
            <a:endParaRPr lang="en-GB" alt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Parentesi graffa aperta 151">
            <a:extLst>
              <a:ext uri="{FF2B5EF4-FFF2-40B4-BE49-F238E27FC236}">
                <a16:creationId xmlns:a16="http://schemas.microsoft.com/office/drawing/2014/main" id="{26405422-1EB4-4E7A-B48A-FD567DC37542}"/>
              </a:ext>
            </a:extLst>
          </p:cNvPr>
          <p:cNvSpPr/>
          <p:nvPr/>
        </p:nvSpPr>
        <p:spPr bwMode="auto">
          <a:xfrm rot="16200000">
            <a:off x="2009101" y="2200017"/>
            <a:ext cx="155995" cy="653649"/>
          </a:xfrm>
          <a:prstGeom prst="leftBrace">
            <a:avLst>
              <a:gd name="adj1" fmla="val 8333"/>
              <a:gd name="adj2" fmla="val 49828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anchor="ctr"/>
          <a:lstStyle/>
          <a:p>
            <a:pPr eaLnBrk="1" hangingPunct="1">
              <a:defRPr/>
            </a:pPr>
            <a:endParaRPr lang="en-GB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6" name="Immagine 275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1041" y="6472712"/>
            <a:ext cx="2465705" cy="2332355"/>
          </a:xfrm>
          <a:prstGeom prst="rect">
            <a:avLst/>
          </a:prstGeom>
        </p:spPr>
      </p:pic>
      <p:pic>
        <p:nvPicPr>
          <p:cNvPr id="277" name="Immagine 276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2946" y="6472712"/>
            <a:ext cx="2466975" cy="2333625"/>
          </a:xfrm>
          <a:prstGeom prst="rect">
            <a:avLst/>
          </a:prstGeom>
        </p:spPr>
      </p:pic>
      <p:sp>
        <p:nvSpPr>
          <p:cNvPr id="278" name="Casella di testo 13"/>
          <p:cNvSpPr txBox="1"/>
          <p:nvPr/>
        </p:nvSpPr>
        <p:spPr>
          <a:xfrm>
            <a:off x="255532" y="6670155"/>
            <a:ext cx="370205" cy="22288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80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2)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9" name="Casella di testo 14"/>
          <p:cNvSpPr txBox="1"/>
          <p:nvPr/>
        </p:nvSpPr>
        <p:spPr>
          <a:xfrm>
            <a:off x="6030449" y="6670155"/>
            <a:ext cx="370205" cy="22288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80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3)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80" name="Casella di testo 20"/>
          <p:cNvSpPr txBox="1"/>
          <p:nvPr/>
        </p:nvSpPr>
        <p:spPr>
          <a:xfrm>
            <a:off x="931488" y="6465918"/>
            <a:ext cx="353060" cy="20574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80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IC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81" name="Casella di testo 21"/>
          <p:cNvSpPr txBox="1"/>
          <p:nvPr/>
        </p:nvSpPr>
        <p:spPr>
          <a:xfrm>
            <a:off x="3479108" y="6474808"/>
            <a:ext cx="353060" cy="20574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80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IC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82" name="Casella di testo 22"/>
          <p:cNvSpPr txBox="1"/>
          <p:nvPr/>
        </p:nvSpPr>
        <p:spPr>
          <a:xfrm>
            <a:off x="931488" y="7021543"/>
            <a:ext cx="556895" cy="20574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80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IC 313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83" name="Casella di testo 23"/>
          <p:cNvSpPr txBox="1"/>
          <p:nvPr/>
        </p:nvSpPr>
        <p:spPr>
          <a:xfrm>
            <a:off x="931488" y="7584788"/>
            <a:ext cx="556895" cy="20574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80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IC 311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84" name="Casella di testo 24"/>
          <p:cNvSpPr txBox="1"/>
          <p:nvPr/>
        </p:nvSpPr>
        <p:spPr>
          <a:xfrm>
            <a:off x="931488" y="8115648"/>
            <a:ext cx="556895" cy="20574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80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IC 330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85" name="Casella di testo 25"/>
          <p:cNvSpPr txBox="1"/>
          <p:nvPr/>
        </p:nvSpPr>
        <p:spPr>
          <a:xfrm>
            <a:off x="3479108" y="7582883"/>
            <a:ext cx="556895" cy="20574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80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IC 299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86" name="Casella di testo 8"/>
          <p:cNvSpPr txBox="1"/>
          <p:nvPr/>
        </p:nvSpPr>
        <p:spPr>
          <a:xfrm>
            <a:off x="514173" y="639853"/>
            <a:ext cx="313690" cy="22288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80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87" name="Casella di testo 12"/>
          <p:cNvSpPr txBox="1"/>
          <p:nvPr/>
        </p:nvSpPr>
        <p:spPr>
          <a:xfrm>
            <a:off x="514173" y="3278278"/>
            <a:ext cx="370205" cy="22288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80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1)</a:t>
            </a:r>
            <a:endParaRPr lang="en-GB" sz="11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88" name="Casella di testo 15"/>
          <p:cNvSpPr txBox="1"/>
          <p:nvPr/>
        </p:nvSpPr>
        <p:spPr>
          <a:xfrm>
            <a:off x="1385371" y="3200606"/>
            <a:ext cx="353060" cy="20574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IC</a:t>
            </a:r>
            <a:endParaRPr lang="en-GB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8" name="Parentesi graffa aperta 37">
            <a:extLst>
              <a:ext uri="{FF2B5EF4-FFF2-40B4-BE49-F238E27FC236}">
                <a16:creationId xmlns:a16="http://schemas.microsoft.com/office/drawing/2014/main" id="{A473D47A-1FB9-4B96-AC55-AA5F14DF04E2}"/>
              </a:ext>
            </a:extLst>
          </p:cNvPr>
          <p:cNvSpPr/>
          <p:nvPr/>
        </p:nvSpPr>
        <p:spPr bwMode="auto">
          <a:xfrm rot="16200000">
            <a:off x="4151856" y="5301825"/>
            <a:ext cx="216000" cy="910645"/>
          </a:xfrm>
          <a:prstGeom prst="leftBrace">
            <a:avLst/>
          </a:prstGeom>
          <a:ln w="12700">
            <a:solidFill>
              <a:srgbClr val="00B0F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GB" sz="728"/>
          </a:p>
        </p:txBody>
      </p:sp>
      <p:sp>
        <p:nvSpPr>
          <p:cNvPr id="39" name="CasellaDiTesto 142">
            <a:extLst>
              <a:ext uri="{FF2B5EF4-FFF2-40B4-BE49-F238E27FC236}">
                <a16:creationId xmlns:a16="http://schemas.microsoft.com/office/drawing/2014/main" id="{B8DE7768-DC49-4266-8086-BAC7B51E65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91994" y="5928558"/>
            <a:ext cx="535724" cy="2994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 eaLnBrk="1" hangingPunct="1">
              <a:defRPr/>
            </a:pPr>
            <a:r>
              <a:rPr lang="it-IT" altLang="en-US" sz="673" dirty="0" err="1">
                <a:latin typeface="Arial" panose="020B0604020202020204" pitchFamily="34" charset="0"/>
                <a:cs typeface="Arial" panose="020B0604020202020204" pitchFamily="34" charset="0"/>
              </a:rPr>
              <a:t>FOHs</a:t>
            </a:r>
            <a:endParaRPr lang="it-IT" altLang="en-US" sz="67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eaLnBrk="1" hangingPunct="1">
              <a:defRPr/>
            </a:pPr>
            <a:r>
              <a:rPr lang="it-IT" altLang="en-US" sz="673" dirty="0">
                <a:latin typeface="Arial" panose="020B0604020202020204" pitchFamily="34" charset="0"/>
                <a:cs typeface="Arial" panose="020B0604020202020204" pitchFamily="34" charset="0"/>
              </a:rPr>
              <a:t>20≤C≤24</a:t>
            </a:r>
            <a:endParaRPr lang="en-GB" altLang="en-US" sz="67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CasellaDiTesto 1"/>
          <p:cNvSpPr txBox="1"/>
          <p:nvPr/>
        </p:nvSpPr>
        <p:spPr>
          <a:xfrm>
            <a:off x="2161115" y="8898794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S1</a:t>
            </a:r>
          </a:p>
        </p:txBody>
      </p:sp>
    </p:spTree>
    <p:extLst>
      <p:ext uri="{BB962C8B-B14F-4D97-AF65-F5344CB8AC3E}">
        <p14:creationId xmlns:p14="http://schemas.microsoft.com/office/powerpoint/2010/main" val="29165279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82</Words>
  <Application>Microsoft Office PowerPoint</Application>
  <PresentationFormat>Personalizzato</PresentationFormat>
  <Paragraphs>3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AMERA EMANUELA</dc:creator>
  <cp:lastModifiedBy>CAMERA EMANUELA</cp:lastModifiedBy>
  <cp:revision>10</cp:revision>
  <dcterms:created xsi:type="dcterms:W3CDTF">2020-12-11T12:53:01Z</dcterms:created>
  <dcterms:modified xsi:type="dcterms:W3CDTF">2021-08-30T14:26:37Z</dcterms:modified>
</cp:coreProperties>
</file>